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41603-8348-4662-B6AB-2F86A0FAFF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E42C5-40CA-44FE-B508-B8FAC0B51E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216E3-324B-4DA2-B41D-76D59E609F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98285-2972-4FFC-BF4C-3C32223274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F40BC-BE9F-4C83-942E-5135E2E19F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B8BED-FC31-4434-B85D-17366453FC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B21E0-A2FC-47D8-B500-CB664611B2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F2DC2-1D5C-4F6A-BC9A-555BE9343A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84E07-5570-4163-9491-C5E67BEBA8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90D15-CDA2-4C1D-96C8-ADD2FB2D39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69EBC-3049-4D8D-B718-37759D6B2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25E64-C57B-45F9-B160-71AC31CF6E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C3A683-C081-4A11-A737-C8643CBE0C6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474000" y="83340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378240" y="917640"/>
            <a:ext cx="90360" cy="182520"/>
          </a:xfrm>
          <a:custGeom>
            <a:avLst/>
            <a:gdLst/>
            <a:ahLst/>
            <a:rect l="l" t="t" r="r" b="b"/>
            <a:pathLst>
              <a:path w="57" h="115">
                <a:moveTo>
                  <a:pt x="0" y="115"/>
                </a:moveTo>
                <a:lnTo>
                  <a:pt x="0" y="0"/>
                </a:lnTo>
                <a:lnTo>
                  <a:pt x="57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573720" y="108432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540240" y="1168560"/>
            <a:ext cx="28440" cy="120600"/>
          </a:xfrm>
          <a:custGeom>
            <a:avLst/>
            <a:gdLst/>
            <a:ahLst/>
            <a:rect l="l" t="t" r="r" b="b"/>
            <a:pathLst>
              <a:path w="18" h="76">
                <a:moveTo>
                  <a:pt x="0" y="76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573720" y="133668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540240" y="1300320"/>
            <a:ext cx="28440" cy="120600"/>
          </a:xfrm>
          <a:custGeom>
            <a:avLst/>
            <a:gdLst/>
            <a:ahLst/>
            <a:rect l="l" t="t" r="r" b="b"/>
            <a:pathLst>
              <a:path w="18" h="76">
                <a:moveTo>
                  <a:pt x="0" y="0"/>
                </a:moveTo>
                <a:lnTo>
                  <a:pt x="0" y="76"/>
                </a:lnTo>
                <a:lnTo>
                  <a:pt x="18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378240" y="1111320"/>
            <a:ext cx="162000" cy="182520"/>
          </a:xfrm>
          <a:custGeom>
            <a:avLst/>
            <a:gdLst/>
            <a:ahLst/>
            <a:rect l="l" t="t" r="r" b="b"/>
            <a:pathLst>
              <a:path w="102" h="115">
                <a:moveTo>
                  <a:pt x="0" y="0"/>
                </a:moveTo>
                <a:lnTo>
                  <a:pt x="0" y="115"/>
                </a:lnTo>
                <a:lnTo>
                  <a:pt x="102" y="11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322800" y="1106640"/>
            <a:ext cx="55440" cy="277560"/>
          </a:xfrm>
          <a:custGeom>
            <a:avLst/>
            <a:gdLst/>
            <a:ahLst/>
            <a:rect l="l" t="t" r="r" b="b"/>
            <a:pathLst>
              <a:path w="35" h="175">
                <a:moveTo>
                  <a:pt x="0" y="175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49960" y="158760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22800" y="1393920"/>
            <a:ext cx="222120" cy="277560"/>
          </a:xfrm>
          <a:custGeom>
            <a:avLst/>
            <a:gdLst/>
            <a:ahLst/>
            <a:rect l="l" t="t" r="r" b="b"/>
            <a:pathLst>
              <a:path w="140" h="175">
                <a:moveTo>
                  <a:pt x="0" y="0"/>
                </a:moveTo>
                <a:lnTo>
                  <a:pt x="0" y="175"/>
                </a:lnTo>
                <a:lnTo>
                  <a:pt x="140" y="17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305160" y="1389240"/>
            <a:ext cx="17640" cy="261720"/>
          </a:xfrm>
          <a:custGeom>
            <a:avLst/>
            <a:gdLst/>
            <a:ahLst/>
            <a:rect l="l" t="t" r="r" b="b"/>
            <a:pathLst>
              <a:path w="11" h="165">
                <a:moveTo>
                  <a:pt x="0" y="165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429360" y="183816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05160" y="1662120"/>
            <a:ext cx="119160" cy="262080"/>
          </a:xfrm>
          <a:custGeom>
            <a:avLst/>
            <a:gdLst/>
            <a:ahLst/>
            <a:rect l="l" t="t" r="r" b="b"/>
            <a:pathLst>
              <a:path w="75" h="165">
                <a:moveTo>
                  <a:pt x="0" y="0"/>
                </a:moveTo>
                <a:lnTo>
                  <a:pt x="0" y="165"/>
                </a:lnTo>
                <a:lnTo>
                  <a:pt x="75" y="16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246480" y="1655640"/>
            <a:ext cx="58680" cy="631800"/>
          </a:xfrm>
          <a:custGeom>
            <a:avLst/>
            <a:gdLst/>
            <a:ahLst/>
            <a:rect l="l" t="t" r="r" b="b"/>
            <a:pathLst>
              <a:path w="37" h="398">
                <a:moveTo>
                  <a:pt x="0" y="398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630960" y="209088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605040" y="2174760"/>
            <a:ext cx="22320" cy="120600"/>
          </a:xfrm>
          <a:custGeom>
            <a:avLst/>
            <a:gdLst/>
            <a:ahLst/>
            <a:rect l="l" t="t" r="r" b="b"/>
            <a:pathLst>
              <a:path w="14" h="76">
                <a:moveTo>
                  <a:pt x="0" y="76"/>
                </a:moveTo>
                <a:lnTo>
                  <a:pt x="0" y="0"/>
                </a:lnTo>
                <a:lnTo>
                  <a:pt x="14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625920" y="234144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605040" y="2305080"/>
            <a:ext cx="16200" cy="120600"/>
          </a:xfrm>
          <a:custGeom>
            <a:avLst/>
            <a:gdLst/>
            <a:ahLst/>
            <a:rect l="l" t="t" r="r" b="b"/>
            <a:pathLst>
              <a:path w="10" h="76">
                <a:moveTo>
                  <a:pt x="0" y="0"/>
                </a:moveTo>
                <a:lnTo>
                  <a:pt x="0" y="76"/>
                </a:lnTo>
                <a:lnTo>
                  <a:pt x="10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597120" y="2300400"/>
            <a:ext cx="7920" cy="245880"/>
          </a:xfrm>
          <a:custGeom>
            <a:avLst/>
            <a:gdLst/>
            <a:ahLst/>
            <a:rect l="l" t="t" r="r" b="b"/>
            <a:pathLst>
              <a:path w="5" h="155">
                <a:moveTo>
                  <a:pt x="0" y="155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656160" y="259380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621240" y="2678040"/>
            <a:ext cx="31680" cy="120600"/>
          </a:xfrm>
          <a:custGeom>
            <a:avLst/>
            <a:gdLst/>
            <a:ahLst/>
            <a:rect l="l" t="t" r="r" b="b"/>
            <a:pathLst>
              <a:path w="20" h="76">
                <a:moveTo>
                  <a:pt x="0" y="76"/>
                </a:moveTo>
                <a:lnTo>
                  <a:pt x="0" y="0"/>
                </a:lnTo>
                <a:lnTo>
                  <a:pt x="20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678840" y="284472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621240" y="2808360"/>
            <a:ext cx="52200" cy="120600"/>
          </a:xfrm>
          <a:custGeom>
            <a:avLst/>
            <a:gdLst/>
            <a:ahLst/>
            <a:rect l="l" t="t" r="r" b="b"/>
            <a:pathLst>
              <a:path w="33" h="76">
                <a:moveTo>
                  <a:pt x="0" y="0"/>
                </a:moveTo>
                <a:lnTo>
                  <a:pt x="0" y="76"/>
                </a:lnTo>
                <a:lnTo>
                  <a:pt x="33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597120" y="2557440"/>
            <a:ext cx="24120" cy="246240"/>
          </a:xfrm>
          <a:custGeom>
            <a:avLst/>
            <a:gdLst/>
            <a:ahLst/>
            <a:rect l="l" t="t" r="r" b="b"/>
            <a:pathLst>
              <a:path w="15" h="155">
                <a:moveTo>
                  <a:pt x="0" y="0"/>
                </a:moveTo>
                <a:lnTo>
                  <a:pt x="0" y="155"/>
                </a:lnTo>
                <a:lnTo>
                  <a:pt x="15" y="15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406680" y="2552760"/>
            <a:ext cx="190440" cy="371520"/>
          </a:xfrm>
          <a:custGeom>
            <a:avLst/>
            <a:gdLst/>
            <a:ahLst/>
            <a:rect l="l" t="t" r="r" b="b"/>
            <a:pathLst>
              <a:path w="120" h="234">
                <a:moveTo>
                  <a:pt x="0" y="234"/>
                </a:moveTo>
                <a:lnTo>
                  <a:pt x="0" y="0"/>
                </a:lnTo>
                <a:lnTo>
                  <a:pt x="120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643560" y="309708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57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448080" y="3181320"/>
            <a:ext cx="191880" cy="120600"/>
          </a:xfrm>
          <a:custGeom>
            <a:avLst/>
            <a:gdLst/>
            <a:ahLst/>
            <a:rect l="l" t="t" r="r" b="b"/>
            <a:pathLst>
              <a:path w="121" h="76">
                <a:moveTo>
                  <a:pt x="0" y="76"/>
                </a:moveTo>
                <a:lnTo>
                  <a:pt x="0" y="0"/>
                </a:lnTo>
                <a:lnTo>
                  <a:pt x="121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728160" y="334800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448080" y="3311640"/>
            <a:ext cx="276120" cy="120600"/>
          </a:xfrm>
          <a:custGeom>
            <a:avLst/>
            <a:gdLst/>
            <a:ahLst/>
            <a:rect l="l" t="t" r="r" b="b"/>
            <a:pathLst>
              <a:path w="174" h="76">
                <a:moveTo>
                  <a:pt x="0" y="0"/>
                </a:moveTo>
                <a:lnTo>
                  <a:pt x="0" y="76"/>
                </a:lnTo>
                <a:lnTo>
                  <a:pt x="174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406680" y="2935440"/>
            <a:ext cx="41400" cy="371160"/>
          </a:xfrm>
          <a:custGeom>
            <a:avLst/>
            <a:gdLst/>
            <a:ahLst/>
            <a:rect l="l" t="t" r="r" b="b"/>
            <a:pathLst>
              <a:path w="26" h="234">
                <a:moveTo>
                  <a:pt x="0" y="0"/>
                </a:moveTo>
                <a:lnTo>
                  <a:pt x="0" y="234"/>
                </a:lnTo>
                <a:lnTo>
                  <a:pt x="26" y="234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246480" y="2298600"/>
            <a:ext cx="160200" cy="630360"/>
          </a:xfrm>
          <a:custGeom>
            <a:avLst/>
            <a:gdLst/>
            <a:ahLst/>
            <a:rect l="l" t="t" r="r" b="b"/>
            <a:pathLst>
              <a:path w="101" h="397">
                <a:moveTo>
                  <a:pt x="0" y="0"/>
                </a:moveTo>
                <a:lnTo>
                  <a:pt x="0" y="397"/>
                </a:lnTo>
                <a:lnTo>
                  <a:pt x="101" y="397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476600" y="841320"/>
            <a:ext cx="59040" cy="2651040"/>
          </a:xfrm>
          <a:custGeom>
            <a:avLst/>
            <a:gdLst/>
            <a:ahLst/>
            <a:rect l="l" t="t" r="r" b="b"/>
            <a:pathLst>
              <a:path w="37" h="1670">
                <a:moveTo>
                  <a:pt x="0" y="0"/>
                </a:moveTo>
                <a:lnTo>
                  <a:pt x="37" y="0"/>
                </a:lnTo>
                <a:lnTo>
                  <a:pt x="37" y="1670"/>
                </a:lnTo>
                <a:lnTo>
                  <a:pt x="0" y="167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664160" y="2085840"/>
            <a:ext cx="298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MS Sans Serif"/>
              </a:rPr>
              <a:t>Cp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800360" y="2293920"/>
            <a:ext cx="1439640" cy="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393000" y="359892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262320" y="3683160"/>
            <a:ext cx="125280" cy="372960"/>
          </a:xfrm>
          <a:custGeom>
            <a:avLst/>
            <a:gdLst/>
            <a:ahLst/>
            <a:rect l="l" t="t" r="r" b="b"/>
            <a:pathLst>
              <a:path w="79" h="235">
                <a:moveTo>
                  <a:pt x="0" y="235"/>
                </a:moveTo>
                <a:lnTo>
                  <a:pt x="0" y="0"/>
                </a:lnTo>
                <a:lnTo>
                  <a:pt x="79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357720" y="385128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49800" y="3935520"/>
            <a:ext cx="4680" cy="120600"/>
          </a:xfrm>
          <a:custGeom>
            <a:avLst/>
            <a:gdLst/>
            <a:ahLst/>
            <a:rect l="l" t="t" r="r" b="b"/>
            <a:pathLst>
              <a:path w="3" h="76">
                <a:moveTo>
                  <a:pt x="0" y="76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358080" y="410220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349800" y="4065480"/>
            <a:ext cx="4680" cy="120600"/>
          </a:xfrm>
          <a:custGeom>
            <a:avLst/>
            <a:gdLst/>
            <a:ahLst/>
            <a:rect l="l" t="t" r="r" b="b"/>
            <a:pathLst>
              <a:path w="3" h="76">
                <a:moveTo>
                  <a:pt x="0" y="0"/>
                </a:moveTo>
                <a:lnTo>
                  <a:pt x="0" y="76"/>
                </a:lnTo>
                <a:lnTo>
                  <a:pt x="3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262320" y="4060800"/>
            <a:ext cx="87480" cy="184320"/>
          </a:xfrm>
          <a:custGeom>
            <a:avLst/>
            <a:gdLst/>
            <a:ahLst/>
            <a:rect l="l" t="t" r="r" b="b"/>
            <a:pathLst>
              <a:path w="55" h="116">
                <a:moveTo>
                  <a:pt x="0" y="116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475440" y="43545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262320" y="4254480"/>
            <a:ext cx="209520" cy="184320"/>
          </a:xfrm>
          <a:custGeom>
            <a:avLst/>
            <a:gdLst/>
            <a:ahLst/>
            <a:rect l="l" t="t" r="r" b="b"/>
            <a:pathLst>
              <a:path w="132" h="116">
                <a:moveTo>
                  <a:pt x="0" y="0"/>
                </a:moveTo>
                <a:lnTo>
                  <a:pt x="0" y="116"/>
                </a:lnTo>
                <a:lnTo>
                  <a:pt x="132" y="11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262320" y="4065480"/>
            <a:ext cx="1440" cy="37332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193920" y="4060800"/>
            <a:ext cx="68400" cy="309600"/>
          </a:xfrm>
          <a:custGeom>
            <a:avLst/>
            <a:gdLst/>
            <a:ahLst/>
            <a:rect l="l" t="t" r="r" b="b"/>
            <a:pathLst>
              <a:path w="43" h="195">
                <a:moveTo>
                  <a:pt x="0" y="195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330000" y="460548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193920" y="4379760"/>
            <a:ext cx="131760" cy="309600"/>
          </a:xfrm>
          <a:custGeom>
            <a:avLst/>
            <a:gdLst/>
            <a:ahLst/>
            <a:rect l="l" t="t" r="r" b="b"/>
            <a:pathLst>
              <a:path w="83" h="195">
                <a:moveTo>
                  <a:pt x="0" y="0"/>
                </a:moveTo>
                <a:lnTo>
                  <a:pt x="0" y="195"/>
                </a:lnTo>
                <a:lnTo>
                  <a:pt x="83" y="19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154320" y="4375080"/>
            <a:ext cx="39600" cy="341280"/>
          </a:xfrm>
          <a:custGeom>
            <a:avLst/>
            <a:gdLst/>
            <a:ahLst/>
            <a:rect l="l" t="t" r="r" b="b"/>
            <a:pathLst>
              <a:path w="25" h="215">
                <a:moveTo>
                  <a:pt x="0" y="215"/>
                </a:moveTo>
                <a:lnTo>
                  <a:pt x="0" y="0"/>
                </a:lnTo>
                <a:lnTo>
                  <a:pt x="25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337200" y="485604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254400" y="4941720"/>
            <a:ext cx="79200" cy="119160"/>
          </a:xfrm>
          <a:custGeom>
            <a:avLst/>
            <a:gdLst/>
            <a:ahLst/>
            <a:rect l="l" t="t" r="r" b="b"/>
            <a:pathLst>
              <a:path w="50" h="75">
                <a:moveTo>
                  <a:pt x="0" y="75"/>
                </a:moveTo>
                <a:lnTo>
                  <a:pt x="0" y="0"/>
                </a:lnTo>
                <a:lnTo>
                  <a:pt x="50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321720" y="510840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254400" y="5072040"/>
            <a:ext cx="63360" cy="120600"/>
          </a:xfrm>
          <a:custGeom>
            <a:avLst/>
            <a:gdLst/>
            <a:ahLst/>
            <a:rect l="l" t="t" r="r" b="b"/>
            <a:pathLst>
              <a:path w="40" h="76">
                <a:moveTo>
                  <a:pt x="0" y="0"/>
                </a:moveTo>
                <a:lnTo>
                  <a:pt x="0" y="76"/>
                </a:lnTo>
                <a:lnTo>
                  <a:pt x="40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154320" y="4726080"/>
            <a:ext cx="100080" cy="341280"/>
          </a:xfrm>
          <a:custGeom>
            <a:avLst/>
            <a:gdLst/>
            <a:ahLst/>
            <a:rect l="l" t="t" r="r" b="b"/>
            <a:pathLst>
              <a:path w="63" h="215">
                <a:moveTo>
                  <a:pt x="0" y="0"/>
                </a:moveTo>
                <a:lnTo>
                  <a:pt x="0" y="215"/>
                </a:lnTo>
                <a:lnTo>
                  <a:pt x="63" y="21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129120" y="4721400"/>
            <a:ext cx="25200" cy="355320"/>
          </a:xfrm>
          <a:custGeom>
            <a:avLst/>
            <a:gdLst/>
            <a:ahLst/>
            <a:rect l="l" t="t" r="r" b="b"/>
            <a:pathLst>
              <a:path w="16" h="224">
                <a:moveTo>
                  <a:pt x="0" y="224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237120" y="535932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129120" y="5087880"/>
            <a:ext cx="104760" cy="355680"/>
          </a:xfrm>
          <a:custGeom>
            <a:avLst/>
            <a:gdLst/>
            <a:ahLst/>
            <a:rect l="l" t="t" r="r" b="b"/>
            <a:pathLst>
              <a:path w="66" h="224">
                <a:moveTo>
                  <a:pt x="0" y="0"/>
                </a:moveTo>
                <a:lnTo>
                  <a:pt x="0" y="224"/>
                </a:lnTo>
                <a:lnTo>
                  <a:pt x="66" y="224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044880" y="5083200"/>
            <a:ext cx="84240" cy="299880"/>
          </a:xfrm>
          <a:custGeom>
            <a:avLst/>
            <a:gdLst/>
            <a:ahLst/>
            <a:rect l="l" t="t" r="r" b="b"/>
            <a:pathLst>
              <a:path w="53" h="189">
                <a:moveTo>
                  <a:pt x="0" y="189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337200" y="561168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044880" y="5394240"/>
            <a:ext cx="288720" cy="301680"/>
          </a:xfrm>
          <a:custGeom>
            <a:avLst/>
            <a:gdLst/>
            <a:ahLst/>
            <a:rect l="l" t="t" r="r" b="b"/>
            <a:pathLst>
              <a:path w="182" h="190">
                <a:moveTo>
                  <a:pt x="0" y="0"/>
                </a:moveTo>
                <a:lnTo>
                  <a:pt x="0" y="190"/>
                </a:lnTo>
                <a:lnTo>
                  <a:pt x="182" y="19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478400" y="3616200"/>
            <a:ext cx="57240" cy="2148120"/>
          </a:xfrm>
          <a:custGeom>
            <a:avLst/>
            <a:gdLst/>
            <a:ahLst/>
            <a:rect l="l" t="t" r="r" b="b"/>
            <a:pathLst>
              <a:path w="36" h="1353">
                <a:moveTo>
                  <a:pt x="0" y="0"/>
                </a:moveTo>
                <a:lnTo>
                  <a:pt x="36" y="0"/>
                </a:lnTo>
                <a:lnTo>
                  <a:pt x="36" y="1353"/>
                </a:lnTo>
                <a:lnTo>
                  <a:pt x="0" y="1353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652640" y="4608360"/>
            <a:ext cx="33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Cpe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800360" y="5389560"/>
            <a:ext cx="1244520" cy="144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795320" y="2292480"/>
            <a:ext cx="1800" cy="154296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795320" y="3846600"/>
            <a:ext cx="1800" cy="154296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517760" y="3840120"/>
            <a:ext cx="277560" cy="1881360"/>
          </a:xfrm>
          <a:custGeom>
            <a:avLst/>
            <a:gdLst/>
            <a:ahLst/>
            <a:rect l="l" t="t" r="r" b="b"/>
            <a:pathLst>
              <a:path w="175" h="1185">
                <a:moveTo>
                  <a:pt x="0" y="1185"/>
                </a:moveTo>
                <a:lnTo>
                  <a:pt x="0" y="0"/>
                </a:lnTo>
                <a:lnTo>
                  <a:pt x="175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506760" y="586260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503520" y="5946840"/>
            <a:ext cx="1800" cy="120600"/>
          </a:xfrm>
          <a:custGeom>
            <a:avLst/>
            <a:gdLst/>
            <a:ahLst/>
            <a:rect l="l" t="t" r="r" b="b"/>
            <a:pathLst>
              <a:path w="0" h="76">
                <a:moveTo>
                  <a:pt x="0" y="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520080" y="61149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503520" y="6078600"/>
            <a:ext cx="12960" cy="120600"/>
          </a:xfrm>
          <a:custGeom>
            <a:avLst/>
            <a:gdLst/>
            <a:ahLst/>
            <a:rect l="l" t="t" r="r" b="b"/>
            <a:pathLst>
              <a:path w="8" h="76">
                <a:moveTo>
                  <a:pt x="0" y="0"/>
                </a:moveTo>
                <a:lnTo>
                  <a:pt x="0" y="76"/>
                </a:lnTo>
                <a:lnTo>
                  <a:pt x="8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343320" y="6072120"/>
            <a:ext cx="160200" cy="184320"/>
          </a:xfrm>
          <a:custGeom>
            <a:avLst/>
            <a:gdLst/>
            <a:ahLst/>
            <a:rect l="l" t="t" r="r" b="b"/>
            <a:pathLst>
              <a:path w="101" h="116">
                <a:moveTo>
                  <a:pt x="0" y="116"/>
                </a:moveTo>
                <a:lnTo>
                  <a:pt x="0" y="0"/>
                </a:lnTo>
                <a:lnTo>
                  <a:pt x="101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502440" y="636588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343320" y="6267600"/>
            <a:ext cx="155520" cy="182520"/>
          </a:xfrm>
          <a:custGeom>
            <a:avLst/>
            <a:gdLst/>
            <a:ahLst/>
            <a:rect l="l" t="t" r="r" b="b"/>
            <a:pathLst>
              <a:path w="98" h="115">
                <a:moveTo>
                  <a:pt x="0" y="0"/>
                </a:moveTo>
                <a:lnTo>
                  <a:pt x="0" y="115"/>
                </a:lnTo>
                <a:lnTo>
                  <a:pt x="98" y="11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289320" y="6261120"/>
            <a:ext cx="54000" cy="216000"/>
          </a:xfrm>
          <a:custGeom>
            <a:avLst/>
            <a:gdLst/>
            <a:ahLst/>
            <a:rect l="l" t="t" r="r" b="b"/>
            <a:pathLst>
              <a:path w="34" h="136">
                <a:moveTo>
                  <a:pt x="0" y="136"/>
                </a:moveTo>
                <a:lnTo>
                  <a:pt x="0" y="0"/>
                </a:lnTo>
                <a:lnTo>
                  <a:pt x="34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489480" y="661680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289320" y="6486480"/>
            <a:ext cx="195120" cy="216000"/>
          </a:xfrm>
          <a:custGeom>
            <a:avLst/>
            <a:gdLst/>
            <a:ahLst/>
            <a:rect l="l" t="t" r="r" b="b"/>
            <a:pathLst>
              <a:path w="123" h="136">
                <a:moveTo>
                  <a:pt x="0" y="0"/>
                </a:moveTo>
                <a:lnTo>
                  <a:pt x="0" y="136"/>
                </a:lnTo>
                <a:lnTo>
                  <a:pt x="123" y="13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254400" y="6481800"/>
            <a:ext cx="34920" cy="230040"/>
          </a:xfrm>
          <a:custGeom>
            <a:avLst/>
            <a:gdLst/>
            <a:ahLst/>
            <a:rect l="l" t="t" r="r" b="b"/>
            <a:pathLst>
              <a:path w="22" h="145">
                <a:moveTo>
                  <a:pt x="0" y="145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453480" y="68691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254400" y="6723000"/>
            <a:ext cx="193680" cy="230400"/>
          </a:xfrm>
          <a:custGeom>
            <a:avLst/>
            <a:gdLst/>
            <a:ahLst/>
            <a:rect l="l" t="t" r="r" b="b"/>
            <a:pathLst>
              <a:path w="122" h="145">
                <a:moveTo>
                  <a:pt x="0" y="0"/>
                </a:moveTo>
                <a:lnTo>
                  <a:pt x="0" y="145"/>
                </a:lnTo>
                <a:lnTo>
                  <a:pt x="122" y="14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246480" y="6716880"/>
            <a:ext cx="7920" cy="239400"/>
          </a:xfrm>
          <a:custGeom>
            <a:avLst/>
            <a:gdLst/>
            <a:ahLst/>
            <a:rect l="l" t="t" r="r" b="b"/>
            <a:pathLst>
              <a:path w="5" h="151">
                <a:moveTo>
                  <a:pt x="0" y="151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429000" y="712008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246480" y="6966000"/>
            <a:ext cx="177840" cy="237960"/>
          </a:xfrm>
          <a:custGeom>
            <a:avLst/>
            <a:gdLst/>
            <a:ahLst/>
            <a:rect l="l" t="t" r="r" b="b"/>
            <a:pathLst>
              <a:path w="112" h="150">
                <a:moveTo>
                  <a:pt x="0" y="0"/>
                </a:moveTo>
                <a:lnTo>
                  <a:pt x="0" y="150"/>
                </a:lnTo>
                <a:lnTo>
                  <a:pt x="112" y="15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176640" y="6961320"/>
            <a:ext cx="69840" cy="303120"/>
          </a:xfrm>
          <a:custGeom>
            <a:avLst/>
            <a:gdLst/>
            <a:ahLst/>
            <a:rect l="l" t="t" r="r" b="b"/>
            <a:pathLst>
              <a:path w="44" h="191">
                <a:moveTo>
                  <a:pt x="0" y="191"/>
                </a:moveTo>
                <a:lnTo>
                  <a:pt x="0" y="0"/>
                </a:lnTo>
                <a:lnTo>
                  <a:pt x="44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494160" y="737244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322800" y="7456320"/>
            <a:ext cx="168120" cy="120960"/>
          </a:xfrm>
          <a:custGeom>
            <a:avLst/>
            <a:gdLst/>
            <a:ahLst/>
            <a:rect l="l" t="t" r="r" b="b"/>
            <a:pathLst>
              <a:path w="106" h="76">
                <a:moveTo>
                  <a:pt x="0" y="76"/>
                </a:moveTo>
                <a:lnTo>
                  <a:pt x="0" y="0"/>
                </a:lnTo>
                <a:lnTo>
                  <a:pt x="106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656880" y="762300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322800" y="7586640"/>
            <a:ext cx="330120" cy="120600"/>
          </a:xfrm>
          <a:custGeom>
            <a:avLst/>
            <a:gdLst/>
            <a:ahLst/>
            <a:rect l="l" t="t" r="r" b="b"/>
            <a:pathLst>
              <a:path w="208" h="76">
                <a:moveTo>
                  <a:pt x="0" y="0"/>
                </a:moveTo>
                <a:lnTo>
                  <a:pt x="0" y="76"/>
                </a:lnTo>
                <a:lnTo>
                  <a:pt x="208" y="76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176640" y="7275600"/>
            <a:ext cx="146160" cy="306360"/>
          </a:xfrm>
          <a:custGeom>
            <a:avLst/>
            <a:gdLst/>
            <a:ahLst/>
            <a:rect l="l" t="t" r="r" b="b"/>
            <a:pathLst>
              <a:path w="92" h="193">
                <a:moveTo>
                  <a:pt x="0" y="0"/>
                </a:moveTo>
                <a:lnTo>
                  <a:pt x="0" y="193"/>
                </a:lnTo>
                <a:lnTo>
                  <a:pt x="92" y="193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052800" y="7270920"/>
            <a:ext cx="123840" cy="336240"/>
          </a:xfrm>
          <a:custGeom>
            <a:avLst/>
            <a:gdLst/>
            <a:ahLst/>
            <a:rect l="l" t="t" r="r" b="b"/>
            <a:pathLst>
              <a:path w="78" h="212">
                <a:moveTo>
                  <a:pt x="0" y="212"/>
                </a:moveTo>
                <a:lnTo>
                  <a:pt x="0" y="0"/>
                </a:lnTo>
                <a:lnTo>
                  <a:pt x="78" y="0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156480" y="787572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052800" y="7618320"/>
            <a:ext cx="100080" cy="341280"/>
          </a:xfrm>
          <a:custGeom>
            <a:avLst/>
            <a:gdLst/>
            <a:ahLst/>
            <a:rect l="l" t="t" r="r" b="b"/>
            <a:pathLst>
              <a:path w="63" h="215">
                <a:moveTo>
                  <a:pt x="0" y="0"/>
                </a:moveTo>
                <a:lnTo>
                  <a:pt x="0" y="215"/>
                </a:lnTo>
                <a:lnTo>
                  <a:pt x="63" y="215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483080" y="5867280"/>
            <a:ext cx="57240" cy="2149560"/>
          </a:xfrm>
          <a:custGeom>
            <a:avLst/>
            <a:gdLst/>
            <a:ahLst/>
            <a:rect l="l" t="t" r="r" b="b"/>
            <a:pathLst>
              <a:path w="36" h="1354">
                <a:moveTo>
                  <a:pt x="0" y="0"/>
                </a:moveTo>
                <a:lnTo>
                  <a:pt x="36" y="0"/>
                </a:lnTo>
                <a:lnTo>
                  <a:pt x="36" y="1354"/>
                </a:lnTo>
                <a:lnTo>
                  <a:pt x="0" y="1354"/>
                </a:lnTo>
              </a:path>
            </a:pathLst>
          </a:custGeom>
          <a:noFill/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672440" y="687240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MS Sans Serif"/>
              </a:rPr>
              <a:t>Cp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522440" y="7613640"/>
            <a:ext cx="1530360" cy="144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517760" y="5732640"/>
            <a:ext cx="1440" cy="188100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401280" y="98424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966760" y="97164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8/60/4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053880" y="128412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25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007800" y="153504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78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215880" y="2089080"/>
            <a:ext cx="3693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7/89/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452400" y="29401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43/-/6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100320" y="2411280"/>
            <a:ext cx="4701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98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109320" y="332100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3/82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985840" y="296064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9/87/7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680560" y="216216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182400" y="476244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3/71/8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277440" y="375444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926800" y="394164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71/39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849040" y="426888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1/40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763360" y="461628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69/74/4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796480" y="49579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68/88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478960" y="542124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491920" y="764532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223800" y="72961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45/29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847600" y="712476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23/34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860200" y="68277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24/17/3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967120" y="6572160"/>
            <a:ext cx="247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5/7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955240" y="63421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21/30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933280" y="61149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5/73/1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952000" y="594036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041560" y="8312040"/>
            <a:ext cx="136440" cy="180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041560" y="8271000"/>
            <a:ext cx="1440" cy="8388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178000" y="8271000"/>
            <a:ext cx="1800" cy="8388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028600" y="8354880"/>
            <a:ext cx="162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849120" y="8604360"/>
            <a:ext cx="277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Six et al., additional data file 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083120" y="1062000"/>
            <a:ext cx="141120" cy="141480"/>
          </a:xfrm>
          <a:prstGeom prst="star5">
            <a:avLst/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076640" y="1319040"/>
            <a:ext cx="142920" cy="14148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4237200" y="3325680"/>
            <a:ext cx="141120" cy="14148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4156200" y="3076560"/>
            <a:ext cx="142920" cy="139680"/>
          </a:xfrm>
          <a:prstGeom prst="star5">
            <a:avLst/>
          </a:prstGeom>
          <a:solidFill>
            <a:srgbClr val="00cc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4195800" y="2575080"/>
            <a:ext cx="14112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156200" y="2824200"/>
            <a:ext cx="14112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908520" y="1814400"/>
            <a:ext cx="142920" cy="139680"/>
          </a:xfrm>
          <a:prstGeom prst="star5">
            <a:avLst/>
          </a:prstGeom>
          <a:solidFill>
            <a:srgbClr val="00cc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2" name=""/>
          <p:cNvGrpSpPr/>
          <p:nvPr/>
        </p:nvGrpSpPr>
        <p:grpSpPr>
          <a:xfrm>
            <a:off x="4038480" y="1574640"/>
            <a:ext cx="144720" cy="142920"/>
            <a:chOff x="4038480" y="1574640"/>
            <a:chExt cx="144720" cy="142920"/>
          </a:xfrm>
        </p:grpSpPr>
        <p:sp>
          <p:nvSpPr>
            <p:cNvPr id="173" name=""/>
            <p:cNvSpPr/>
            <p:nvPr/>
          </p:nvSpPr>
          <p:spPr>
            <a:xfrm>
              <a:off x="4038480" y="1574640"/>
              <a:ext cx="144720" cy="13500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" bIns="-1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111560" y="1574640"/>
              <a:ext cx="32760" cy="10404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rot="19380000">
              <a:off x="4126320" y="16081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rot="5400000">
              <a:off x="4133160" y="1620360"/>
              <a:ext cx="37800" cy="547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800" bIns="-28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rot="9763200">
              <a:off x="4116960" y="16714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128480" y="16261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4138560" y="16261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111560" y="15746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138560" y="165816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111560" y="16786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138560" y="165888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113720" y="1679760"/>
              <a:ext cx="41040" cy="2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5" name=""/>
          <p:cNvGrpSpPr/>
          <p:nvPr/>
        </p:nvGrpSpPr>
        <p:grpSpPr>
          <a:xfrm>
            <a:off x="4137120" y="2076480"/>
            <a:ext cx="144360" cy="142920"/>
            <a:chOff x="4137120" y="2076480"/>
            <a:chExt cx="144360" cy="142920"/>
          </a:xfrm>
        </p:grpSpPr>
        <p:sp>
          <p:nvSpPr>
            <p:cNvPr id="186" name=""/>
            <p:cNvSpPr/>
            <p:nvPr/>
          </p:nvSpPr>
          <p:spPr>
            <a:xfrm>
              <a:off x="4137120" y="20764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209840" y="20764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rot="19380000">
              <a:off x="4224600" y="21099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rot="5400000">
              <a:off x="4231440" y="21225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rot="9763200">
              <a:off x="4215240" y="21733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227120" y="21279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4237200" y="21279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209840" y="20764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237200" y="21596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209840" y="21801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237200" y="21607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212000" y="21812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8" name=""/>
          <p:cNvGrpSpPr/>
          <p:nvPr/>
        </p:nvGrpSpPr>
        <p:grpSpPr>
          <a:xfrm>
            <a:off x="3914640" y="3575160"/>
            <a:ext cx="144720" cy="142920"/>
            <a:chOff x="3914640" y="3575160"/>
            <a:chExt cx="144720" cy="142920"/>
          </a:xfrm>
        </p:grpSpPr>
        <p:sp>
          <p:nvSpPr>
            <p:cNvPr id="199" name=""/>
            <p:cNvSpPr/>
            <p:nvPr/>
          </p:nvSpPr>
          <p:spPr>
            <a:xfrm>
              <a:off x="3914640" y="3575160"/>
              <a:ext cx="14472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987720" y="357516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rot="19380000">
              <a:off x="4002480" y="360864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rot="5400000">
              <a:off x="4009320" y="3620880"/>
              <a:ext cx="37800" cy="547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800" bIns="-28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rot="9763200">
              <a:off x="3993120" y="367200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004640" y="362664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V="1">
              <a:off x="4014720" y="362664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987720" y="357516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014720" y="36583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3987720" y="367884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014720" y="36594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3989880" y="3679920"/>
              <a:ext cx="4104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1" name=""/>
          <p:cNvGrpSpPr/>
          <p:nvPr/>
        </p:nvGrpSpPr>
        <p:grpSpPr>
          <a:xfrm>
            <a:off x="3954600" y="814320"/>
            <a:ext cx="144360" cy="142920"/>
            <a:chOff x="3954600" y="814320"/>
            <a:chExt cx="144360" cy="142920"/>
          </a:xfrm>
        </p:grpSpPr>
        <p:sp>
          <p:nvSpPr>
            <p:cNvPr id="212" name=""/>
            <p:cNvSpPr/>
            <p:nvPr/>
          </p:nvSpPr>
          <p:spPr>
            <a:xfrm>
              <a:off x="3954600" y="81432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027320" y="81432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 rot="19380000">
              <a:off x="4042080" y="84780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rot="5400000">
              <a:off x="4048920" y="86040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rot="9763200">
              <a:off x="4032720" y="91116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044600" y="86580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4054680" y="86580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027320" y="81432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054680" y="8974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027320" y="91800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054680" y="8985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029480" y="91908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4" name=""/>
          <p:cNvGrpSpPr/>
          <p:nvPr/>
        </p:nvGrpSpPr>
        <p:grpSpPr>
          <a:xfrm>
            <a:off x="4044960" y="2320920"/>
            <a:ext cx="144360" cy="142920"/>
            <a:chOff x="4044960" y="2320920"/>
            <a:chExt cx="144360" cy="142920"/>
          </a:xfrm>
        </p:grpSpPr>
        <p:sp>
          <p:nvSpPr>
            <p:cNvPr id="225" name=""/>
            <p:cNvSpPr/>
            <p:nvPr/>
          </p:nvSpPr>
          <p:spPr>
            <a:xfrm>
              <a:off x="4044960" y="232092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117680" y="232092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rot="19380000">
              <a:off x="4132440" y="235440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rot="5400000">
              <a:off x="4139280" y="236700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rot="9763200">
              <a:off x="4123080" y="241776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134960" y="237240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4145040" y="237240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117680" y="232092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145040" y="24040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117680" y="242460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145040" y="24051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119840" y="242568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7" name=""/>
          <p:cNvSpPr/>
          <p:nvPr/>
        </p:nvSpPr>
        <p:spPr>
          <a:xfrm>
            <a:off x="3854520" y="5586480"/>
            <a:ext cx="141120" cy="141120"/>
          </a:xfrm>
          <a:prstGeom prst="star5">
            <a:avLst/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763800" y="5338800"/>
            <a:ext cx="142920" cy="14112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860640" y="4578480"/>
            <a:ext cx="141480" cy="14112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860640" y="4834080"/>
            <a:ext cx="14148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832200" y="5083200"/>
            <a:ext cx="14148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2" name=""/>
          <p:cNvGrpSpPr/>
          <p:nvPr/>
        </p:nvGrpSpPr>
        <p:grpSpPr>
          <a:xfrm>
            <a:off x="3854520" y="4089240"/>
            <a:ext cx="144360" cy="142920"/>
            <a:chOff x="3854520" y="4089240"/>
            <a:chExt cx="144360" cy="142920"/>
          </a:xfrm>
        </p:grpSpPr>
        <p:sp>
          <p:nvSpPr>
            <p:cNvPr id="243" name=""/>
            <p:cNvSpPr/>
            <p:nvPr/>
          </p:nvSpPr>
          <p:spPr>
            <a:xfrm>
              <a:off x="3854520" y="4089240"/>
              <a:ext cx="144360" cy="13500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" bIns="-1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3927240" y="4089240"/>
              <a:ext cx="32760" cy="10404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rot="19380000">
              <a:off x="3942000" y="41227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rot="5400000">
              <a:off x="3948840" y="41353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rot="9763200">
              <a:off x="3932640" y="41860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944520" y="41407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V="1">
              <a:off x="3954600" y="41407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3927240" y="40892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954600" y="417276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927240" y="41932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954600" y="417348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929400" y="4194360"/>
              <a:ext cx="40680" cy="2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5" name=""/>
          <p:cNvGrpSpPr/>
          <p:nvPr/>
        </p:nvGrpSpPr>
        <p:grpSpPr>
          <a:xfrm>
            <a:off x="3967200" y="4336920"/>
            <a:ext cx="144360" cy="142920"/>
            <a:chOff x="3967200" y="4336920"/>
            <a:chExt cx="144360" cy="142920"/>
          </a:xfrm>
        </p:grpSpPr>
        <p:sp>
          <p:nvSpPr>
            <p:cNvPr id="256" name=""/>
            <p:cNvSpPr/>
            <p:nvPr/>
          </p:nvSpPr>
          <p:spPr>
            <a:xfrm>
              <a:off x="3967200" y="433692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039920" y="433692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rot="19380000">
              <a:off x="4054680" y="437040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rot="5400000">
              <a:off x="4061520" y="438300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rot="9763200">
              <a:off x="4045320" y="443376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057200" y="438840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4067280" y="438840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039920" y="433692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067280" y="44200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4039920" y="444060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067280" y="44211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4042080" y="444168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8" name=""/>
          <p:cNvGrpSpPr/>
          <p:nvPr/>
        </p:nvGrpSpPr>
        <p:grpSpPr>
          <a:xfrm>
            <a:off x="3914640" y="5848200"/>
            <a:ext cx="144720" cy="142920"/>
            <a:chOff x="3914640" y="5848200"/>
            <a:chExt cx="144720" cy="142920"/>
          </a:xfrm>
        </p:grpSpPr>
        <p:sp>
          <p:nvSpPr>
            <p:cNvPr id="269" name=""/>
            <p:cNvSpPr/>
            <p:nvPr/>
          </p:nvSpPr>
          <p:spPr>
            <a:xfrm>
              <a:off x="3914640" y="5848200"/>
              <a:ext cx="14472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3987720" y="58482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rot="19380000">
              <a:off x="4002480" y="58816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 rot="5400000">
              <a:off x="4009320" y="5893920"/>
              <a:ext cx="37800" cy="547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800" bIns="-28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rot="9763200">
              <a:off x="3993120" y="59450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004640" y="58996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4014720" y="58996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987720" y="58482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4014720" y="59313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987720" y="59518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4014720" y="59324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989880" y="5952960"/>
              <a:ext cx="4104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1" name=""/>
          <p:cNvGrpSpPr/>
          <p:nvPr/>
        </p:nvGrpSpPr>
        <p:grpSpPr>
          <a:xfrm>
            <a:off x="3776760" y="3832200"/>
            <a:ext cx="144360" cy="142920"/>
            <a:chOff x="3776760" y="3832200"/>
            <a:chExt cx="144360" cy="142920"/>
          </a:xfrm>
        </p:grpSpPr>
        <p:sp>
          <p:nvSpPr>
            <p:cNvPr id="282" name=""/>
            <p:cNvSpPr/>
            <p:nvPr/>
          </p:nvSpPr>
          <p:spPr>
            <a:xfrm>
              <a:off x="3776760" y="383220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3849480" y="38322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rot="19380000">
              <a:off x="3864240" y="38656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rot="5400000">
              <a:off x="3871080" y="387828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 rot="9763200">
              <a:off x="3854880" y="39290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3866760" y="38836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 flipV="1">
              <a:off x="3876840" y="38836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3849480" y="38322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3876840" y="39153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849480" y="39358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3876840" y="39164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851640" y="393696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4" name=""/>
          <p:cNvGrpSpPr/>
          <p:nvPr/>
        </p:nvGrpSpPr>
        <p:grpSpPr>
          <a:xfrm>
            <a:off x="4005360" y="6097680"/>
            <a:ext cx="144360" cy="142920"/>
            <a:chOff x="4005360" y="6097680"/>
            <a:chExt cx="144360" cy="142920"/>
          </a:xfrm>
        </p:grpSpPr>
        <p:sp>
          <p:nvSpPr>
            <p:cNvPr id="295" name=""/>
            <p:cNvSpPr/>
            <p:nvPr/>
          </p:nvSpPr>
          <p:spPr>
            <a:xfrm>
              <a:off x="4005360" y="60976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078080" y="60976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 rot="19380000">
              <a:off x="4092840" y="61311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 rot="5400000">
              <a:off x="4099680" y="61437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rot="9763200">
              <a:off x="4083480" y="61945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4095360" y="61491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 flipV="1">
              <a:off x="4105440" y="61491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078080" y="60976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4105440" y="61808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078080" y="62013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105440" y="61819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080240" y="62024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7" name=""/>
          <p:cNvSpPr/>
          <p:nvPr/>
        </p:nvSpPr>
        <p:spPr>
          <a:xfrm>
            <a:off x="4005360" y="7353360"/>
            <a:ext cx="141120" cy="141120"/>
          </a:xfrm>
          <a:prstGeom prst="star5">
            <a:avLst/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4013280" y="6599160"/>
            <a:ext cx="142920" cy="14148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4162320" y="7602480"/>
            <a:ext cx="141480" cy="14148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3973680" y="6851520"/>
            <a:ext cx="141120" cy="14148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970440" y="7101000"/>
            <a:ext cx="14112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2" name=""/>
          <p:cNvGrpSpPr/>
          <p:nvPr/>
        </p:nvGrpSpPr>
        <p:grpSpPr>
          <a:xfrm>
            <a:off x="3651120" y="7859880"/>
            <a:ext cx="144720" cy="142920"/>
            <a:chOff x="3651120" y="7859880"/>
            <a:chExt cx="144720" cy="142920"/>
          </a:xfrm>
        </p:grpSpPr>
        <p:sp>
          <p:nvSpPr>
            <p:cNvPr id="313" name=""/>
            <p:cNvSpPr/>
            <p:nvPr/>
          </p:nvSpPr>
          <p:spPr>
            <a:xfrm>
              <a:off x="3651120" y="7859880"/>
              <a:ext cx="14472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3724200" y="78598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rot="19380000">
              <a:off x="3738960" y="78933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rot="5400000">
              <a:off x="3745800" y="7905600"/>
              <a:ext cx="37800" cy="547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800" bIns="-28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rot="9763200">
              <a:off x="3729600" y="79567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3741120" y="79113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V="1">
              <a:off x="3751200" y="79113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3724200" y="78598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3751200" y="79430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724200" y="79635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751200" y="79441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726360" y="7964640"/>
              <a:ext cx="4104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5" name=""/>
          <p:cNvGrpSpPr/>
          <p:nvPr/>
        </p:nvGrpSpPr>
        <p:grpSpPr>
          <a:xfrm>
            <a:off x="4005360" y="6346800"/>
            <a:ext cx="144360" cy="142920"/>
            <a:chOff x="4005360" y="6346800"/>
            <a:chExt cx="144360" cy="142920"/>
          </a:xfrm>
        </p:grpSpPr>
        <p:sp>
          <p:nvSpPr>
            <p:cNvPr id="326" name=""/>
            <p:cNvSpPr/>
            <p:nvPr/>
          </p:nvSpPr>
          <p:spPr>
            <a:xfrm>
              <a:off x="4005360" y="634680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4078080" y="63468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 rot="19380000">
              <a:off x="4092840" y="63802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rot="5400000">
              <a:off x="4099680" y="639288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 rot="9763200">
              <a:off x="4083480" y="64436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4095360" y="63982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 flipV="1">
              <a:off x="4105440" y="63982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4078080" y="63468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105440" y="64299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078080" y="64504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105440" y="64310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4080240" y="645156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8" name=""/>
          <p:cNvSpPr/>
          <p:nvPr/>
        </p:nvSpPr>
        <p:spPr>
          <a:xfrm>
            <a:off x="3481560" y="1096920"/>
            <a:ext cx="0" cy="142920"/>
          </a:xfrm>
          <a:prstGeom prst="line">
            <a:avLst/>
          </a:prstGeom>
          <a:ln w="3240">
            <a:solidFill>
              <a:srgbClr val="000000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3313080" y="3870360"/>
            <a:ext cx="0" cy="142920"/>
          </a:xfrm>
          <a:prstGeom prst="line">
            <a:avLst/>
          </a:prstGeom>
          <a:ln w="3240">
            <a:solidFill>
              <a:srgbClr val="000000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213000" y="4881600"/>
            <a:ext cx="0" cy="142920"/>
          </a:xfrm>
          <a:prstGeom prst="line">
            <a:avLst/>
          </a:prstGeom>
          <a:ln w="3240">
            <a:solidFill>
              <a:srgbClr val="000000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270240" y="7415280"/>
            <a:ext cx="0" cy="142920"/>
          </a:xfrm>
          <a:prstGeom prst="line">
            <a:avLst/>
          </a:prstGeom>
          <a:ln w="3240">
            <a:solidFill>
              <a:srgbClr val="000000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6T13:03:32Z</dcterms:created>
  <dc:creator>Laurence Garczarek</dc:creator>
  <dc:description/>
  <dc:language>en-US</dc:language>
  <cp:lastModifiedBy>Fred Partensky</cp:lastModifiedBy>
  <dcterms:modified xsi:type="dcterms:W3CDTF">2007-11-29T15:21:02Z</dcterms:modified>
  <cp:revision>30</cp:revision>
  <dc:subject/>
  <dc:title>Diapositive 1</dc:title>
</cp:coreProperties>
</file>